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57BE00-8CFD-4BD2-9BB4-355677976FC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72BBFA-DCA6-4270-9B9F-EE5437ED06C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E3417F-3864-431D-B843-F18B4A742A0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80F35A-83BD-463E-9A52-94ACEF0FFF0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F675A4-229E-4505-BC19-AE25B70F7D6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CCEC62-429C-4AE6-807A-45B382CFABF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8F76A7-8039-4382-B4DA-C644D860A1B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2BC48C-D544-4DAC-8A93-F8578BA4AF5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8361BF-5860-4110-9FE4-F575D515A88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89BFB7-8DC8-41A4-9859-92EBE5D3B3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E86942-4A2D-4E7E-9F60-F7A28F75FE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CC9C2A-FD58-4F65-B7C3-12D6D1775C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l-G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l-G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E9F9824-EE14-4BFF-A5FF-2023D874D63A}" type="slidenum">
              <a:rPr b="0" lang="el-G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3"/>
          <p:cNvSpPr/>
          <p:nvPr/>
        </p:nvSpPr>
        <p:spPr>
          <a:xfrm>
            <a:off x="2906280" y="34920"/>
            <a:ext cx="2026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Design of the Stud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Box 4"/>
          <p:cNvSpPr/>
          <p:nvPr/>
        </p:nvSpPr>
        <p:spPr>
          <a:xfrm>
            <a:off x="1341360" y="698400"/>
            <a:ext cx="5353200" cy="642600"/>
          </a:xfrm>
          <a:prstGeom prst="rect">
            <a:avLst/>
          </a:prstGeom>
          <a:solidFill>
            <a:srgbClr val="ffffff"/>
          </a:solidFill>
          <a:ln w="255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LAST2p protein-protein comparison of </a:t>
            </a:r>
            <a:r>
              <a:rPr b="0" lang="el-GR" sz="1800" spc="-1" strike="noStrike">
                <a:solidFill>
                  <a:srgbClr val="000000"/>
                </a:solidFill>
                <a:latin typeface="Calibri"/>
              </a:rPr>
              <a:t> 5 </a:t>
            </a: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 MEASA with 56 intestinal protei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5"/>
          <p:cNvSpPr/>
          <p:nvPr/>
        </p:nvSpPr>
        <p:spPr>
          <a:xfrm>
            <a:off x="263160" y="627120"/>
            <a:ext cx="77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Step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6"/>
          <p:cNvSpPr/>
          <p:nvPr/>
        </p:nvSpPr>
        <p:spPr>
          <a:xfrm>
            <a:off x="1351080" y="2992320"/>
            <a:ext cx="5063760" cy="916920"/>
          </a:xfrm>
          <a:prstGeom prst="rect">
            <a:avLst/>
          </a:prstGeom>
          <a:solidFill>
            <a:srgbClr val="ffffff"/>
          </a:solidFill>
          <a:ln w="255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Detailed BLATP2p analysis  of the results from step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reveals 44 matches from viral (VGFL or HEMA) /self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roteins. These pairs are further analyse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7"/>
          <p:cNvSpPr/>
          <p:nvPr/>
        </p:nvSpPr>
        <p:spPr>
          <a:xfrm>
            <a:off x="263160" y="2992320"/>
            <a:ext cx="77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Step </a:t>
            </a:r>
            <a:r>
              <a:rPr b="1" lang="el-GR" sz="1800" spc="-1" strike="noStrike">
                <a:solidFill>
                  <a:srgbClr val="000000"/>
                </a:solidFill>
                <a:latin typeface="Calibri"/>
              </a:rPr>
              <a:t>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11"/>
          <p:cNvSpPr/>
          <p:nvPr/>
        </p:nvSpPr>
        <p:spPr>
          <a:xfrm>
            <a:off x="1341360" y="4313160"/>
            <a:ext cx="5256360" cy="3111480"/>
          </a:xfrm>
          <a:prstGeom prst="rect">
            <a:avLst/>
          </a:prstGeom>
          <a:solidFill>
            <a:srgbClr val="ffffff"/>
          </a:solidFill>
          <a:ln w="255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mongst the 44 pairs, 17 (39%) pairs of various aa length are identified as ideal matches for  15-meric peptide construction based on the following criteria: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Calibri"/>
              <a:buAutoNum type="arabicParenR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Low hydrophobicity indices of the 15-meric viral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     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nd/or self peptides encompassing the mimicking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     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air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Calibri"/>
              <a:buAutoNum type="arabicParenR" startAt="2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High antigenicity indices  of the viral and/or self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     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15-meric pairs based on the  Emini and/o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     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epipred  B-epitope prediction</a:t>
            </a:r>
            <a:r>
              <a:rPr b="0" lang="el-GR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nalyses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800" spc="-1" strike="noStrike">
                <a:solidFill>
                  <a:srgbClr val="000000"/>
                </a:solidFill>
                <a:latin typeface="Calibri"/>
              </a:rPr>
              <a:t>3)  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Known antigenicity  of the  MEASE mimics, as it has been established  </a:t>
            </a: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via 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literature search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12"/>
          <p:cNvSpPr/>
          <p:nvPr/>
        </p:nvSpPr>
        <p:spPr>
          <a:xfrm>
            <a:off x="263160" y="4240080"/>
            <a:ext cx="77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Step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8" name="Straight Arrow Connector 17"/>
          <p:cNvCxnSpPr/>
          <p:nvPr/>
        </p:nvCxnSpPr>
        <p:spPr>
          <a:xfrm>
            <a:off x="3789000" y="2343240"/>
            <a:ext cx="1080" cy="21816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cxnSp>
        <p:nvCxnSpPr>
          <p:cNvPr id="49" name="Straight Arrow Connector 19"/>
          <p:cNvCxnSpPr/>
          <p:nvPr/>
        </p:nvCxnSpPr>
        <p:spPr>
          <a:xfrm>
            <a:off x="3789000" y="4011480"/>
            <a:ext cx="1080" cy="21672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sp>
        <p:nvSpPr>
          <p:cNvPr id="50" name="TextBox 20"/>
          <p:cNvSpPr/>
          <p:nvPr/>
        </p:nvSpPr>
        <p:spPr>
          <a:xfrm>
            <a:off x="1359720" y="7824960"/>
            <a:ext cx="5286240" cy="916920"/>
          </a:xfrm>
          <a:prstGeom prst="rect">
            <a:avLst/>
          </a:prstGeom>
          <a:solidFill>
            <a:srgbClr val="ffffff"/>
          </a:solidFill>
          <a:ln w="255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15-meric peptides spanning the mimicking sequenc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re constructed and reactivity to MEASE and intestinal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mimics are tested by ELIS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7"/>
          <p:cNvSpPr/>
          <p:nvPr/>
        </p:nvSpPr>
        <p:spPr>
          <a:xfrm>
            <a:off x="263160" y="7824960"/>
            <a:ext cx="77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Step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2" name="Straight Arrow Connector 22"/>
          <p:cNvCxnSpPr/>
          <p:nvPr/>
        </p:nvCxnSpPr>
        <p:spPr>
          <a:xfrm>
            <a:off x="3789000" y="7524720"/>
            <a:ext cx="1080" cy="21672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sp>
        <p:nvSpPr>
          <p:cNvPr id="53" name="TextBox 13"/>
          <p:cNvSpPr/>
          <p:nvPr/>
        </p:nvSpPr>
        <p:spPr>
          <a:xfrm>
            <a:off x="1358280" y="1635120"/>
            <a:ext cx="5297040" cy="916920"/>
          </a:xfrm>
          <a:prstGeom prst="rect">
            <a:avLst/>
          </a:prstGeom>
          <a:solidFill>
            <a:srgbClr val="ffffff"/>
          </a:solidFill>
          <a:ln w="25560">
            <a:solidFill>
              <a:srgbClr val="4f81b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LATP2p analysis identifies </a:t>
            </a:r>
            <a:r>
              <a:rPr b="0" lang="el-GR" sz="1800" spc="-1" strike="noStrike">
                <a:solidFill>
                  <a:srgbClr val="000000"/>
                </a:solidFill>
                <a:latin typeface="Calibri"/>
              </a:rPr>
              <a:t> 2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2/5, 40%) MEASA (VGFL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nd HEMA) antigens and 10 (10/56,18%) intestinal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roteins sharing significant  local aa homology  (&gt;75%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7"/>
          <p:cNvSpPr/>
          <p:nvPr/>
        </p:nvSpPr>
        <p:spPr>
          <a:xfrm>
            <a:off x="336600" y="1635120"/>
            <a:ext cx="825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Step 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5" name="Straight Arrow Connector 15"/>
          <p:cNvCxnSpPr/>
          <p:nvPr/>
        </p:nvCxnSpPr>
        <p:spPr>
          <a:xfrm>
            <a:off x="3862080" y="1347840"/>
            <a:ext cx="1080" cy="21816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cxnSp>
        <p:nvCxnSpPr>
          <p:cNvPr id="56" name="Straight Arrow Connector 16"/>
          <p:cNvCxnSpPr/>
          <p:nvPr/>
        </p:nvCxnSpPr>
        <p:spPr>
          <a:xfrm>
            <a:off x="3789000" y="2714400"/>
            <a:ext cx="1080" cy="21636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6-11T09:03:02Z</dcterms:created>
  <dc:creator>EIR</dc:creator>
  <dc:description/>
  <dc:language>en-US</dc:language>
  <cp:lastModifiedBy>EIR</cp:lastModifiedBy>
  <dcterms:modified xsi:type="dcterms:W3CDTF">2014-06-11T17:31:49Z</dcterms:modified>
  <cp:revision>14</cp:revision>
  <dc:subject/>
  <dc:title>Slide 1</dc:title>
</cp:coreProperties>
</file>